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17" autoAdjust="0"/>
    <p:restoredTop sz="94660"/>
  </p:normalViewPr>
  <p:slideViewPr>
    <p:cSldViewPr snapToGrid="0">
      <p:cViewPr>
        <p:scale>
          <a:sx n="150" d="100"/>
          <a:sy n="150" d="100"/>
        </p:scale>
        <p:origin x="322" y="-24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ocuments\Results\RNA%20n%20RT-PCR\qRT-PCR\Soybean\ABA%20responsive%20gene%20tested%20qRT-PCR%20ABA%20treated%20soybean%20branch%20roots%20Sep27%20202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/>
            </a:pPr>
            <a:r>
              <a:rPr lang="en-US" sz="800" b="0" i="1"/>
              <a:t>GmGolS1</a:t>
            </a:r>
          </a:p>
        </c:rich>
      </c:tx>
      <c:layout>
        <c:manualLayout>
          <c:xMode val="edge"/>
          <c:yMode val="edge"/>
          <c:x val="0.26548620030492937"/>
          <c:y val="0.23661872861758187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8794565189302747"/>
          <c:y val="0.33493199225747211"/>
          <c:w val="0.14980533696311976"/>
          <c:h val="0.43424013664699629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DBE-4E53-8FE3-8CDDAF5A5608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ADBE-4E53-8FE3-8CDDAF5A560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DBE-4E53-8FE3-8CDDAF5A5608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</c15:spPr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qGOL!$J$45:$J$46</c:f>
                <c:numCache>
                  <c:formatCode>General</c:formatCode>
                  <c:ptCount val="2"/>
                  <c:pt idx="0">
                    <c:v>4.0604947686809255E-5</c:v>
                  </c:pt>
                  <c:pt idx="1">
                    <c:v>2.6614394009647765E-4</c:v>
                  </c:pt>
                </c:numCache>
              </c:numRef>
            </c:plus>
            <c:minus>
              <c:numRef>
                <c:f>qGOL!$J$45:$J$46</c:f>
                <c:numCache>
                  <c:formatCode>General</c:formatCode>
                  <c:ptCount val="2"/>
                  <c:pt idx="0">
                    <c:v>4.0604947686809255E-5</c:v>
                  </c:pt>
                  <c:pt idx="1">
                    <c:v>2.6614394009647765E-4</c:v>
                  </c:pt>
                </c:numCache>
              </c:numRef>
            </c:minus>
            <c:spPr>
              <a:ln w="12700"/>
            </c:spPr>
          </c:errBars>
          <c:cat>
            <c:strRef>
              <c:f>qGOL!$H$45:$H$46</c:f>
              <c:strCache>
                <c:ptCount val="2"/>
                <c:pt idx="0">
                  <c:v>Control</c:v>
                </c:pt>
                <c:pt idx="1">
                  <c:v>ABA</c:v>
                </c:pt>
              </c:strCache>
            </c:strRef>
          </c:cat>
          <c:val>
            <c:numRef>
              <c:f>qGOL!$I$45:$I$46</c:f>
              <c:numCache>
                <c:formatCode>General</c:formatCode>
                <c:ptCount val="2"/>
                <c:pt idx="0">
                  <c:v>2.6880324491392824E-4</c:v>
                </c:pt>
                <c:pt idx="1">
                  <c:v>1.297318469149375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DBE-4E53-8FE3-8CDDAF5A56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1.8000000000000004E-3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CA" sz="800" b="0" i="0" baseline="0" dirty="0">
                    <a:effectLst/>
                  </a:rPr>
                  <a:t>Log2 Fold Change (Gene/</a:t>
                </a:r>
                <a:r>
                  <a:rPr lang="en-CA" sz="800" b="0" i="1" baseline="0" dirty="0">
                    <a:effectLst/>
                  </a:rPr>
                  <a:t>UBIQUITIN3</a:t>
                </a:r>
                <a:r>
                  <a:rPr lang="en-CA" sz="800" b="0" i="0" baseline="0" dirty="0">
                    <a:effectLst/>
                  </a:rPr>
                  <a:t>)</a:t>
                </a:r>
                <a:endParaRPr lang="en-CA" sz="8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123680076993617E-2"/>
              <c:y val="0.3074091300482053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  <c:majorUnit val="4.0000000000000013E-4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17073809528798223"/>
          <c:y val="0.80713447279339445"/>
          <c:w val="0.68734333607811671"/>
          <c:h val="0.18899125607578937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/>
            </a:pPr>
            <a:r>
              <a:rPr lang="en-US" sz="800" b="0" i="1"/>
              <a:t>GmGolS1</a:t>
            </a:r>
          </a:p>
        </c:rich>
      </c:tx>
      <c:layout>
        <c:manualLayout>
          <c:xMode val="edge"/>
          <c:yMode val="edge"/>
          <c:x val="0.29209593192378586"/>
          <c:y val="0.2302534966174054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8794565189302747"/>
          <c:y val="0.33493199225747211"/>
          <c:w val="0.14980533696311976"/>
          <c:h val="0.43424013664699629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728-4EE4-8B57-7ED4DBA962C2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728-4EE4-8B57-7ED4DBA962C2}"/>
                </c:ext>
              </c:extLst>
            </c:dLbl>
            <c:dLbl>
              <c:idx val="1"/>
              <c:tx>
                <c:rich>
                  <a:bodyPr wrap="square" lIns="38100" tIns="91440" rIns="38100" bIns="19050" anchor="ctr">
                    <a:spAutoFit/>
                  </a:bodyPr>
                  <a:lstStyle/>
                  <a:p>
                    <a:pPr>
                      <a:defRPr/>
                    </a:pPr>
                    <a:r>
                      <a:rPr lang="en-US" dirty="0"/>
                      <a:t>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</c:ext>
                <c:ext xmlns:c16="http://schemas.microsoft.com/office/drawing/2014/chart" uri="{C3380CC4-5D6E-409C-BE32-E72D297353CC}">
                  <c16:uniqueId val="{00000001-B728-4EE4-8B57-7ED4DBA962C2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</c15:spPr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qGOL!$J$45:$J$46</c:f>
                <c:numCache>
                  <c:formatCode>General</c:formatCode>
                  <c:ptCount val="2"/>
                  <c:pt idx="0">
                    <c:v>4.0604947686809255E-5</c:v>
                  </c:pt>
                  <c:pt idx="1">
                    <c:v>2.6614394009647765E-4</c:v>
                  </c:pt>
                </c:numCache>
              </c:numRef>
            </c:plus>
            <c:minus>
              <c:numRef>
                <c:f>qGOL!$J$45:$J$46</c:f>
                <c:numCache>
                  <c:formatCode>General</c:formatCode>
                  <c:ptCount val="2"/>
                  <c:pt idx="0">
                    <c:v>4.0604947686809255E-5</c:v>
                  </c:pt>
                  <c:pt idx="1">
                    <c:v>2.6614394009647765E-4</c:v>
                  </c:pt>
                </c:numCache>
              </c:numRef>
            </c:minus>
            <c:spPr>
              <a:ln w="12700"/>
            </c:spPr>
          </c:errBars>
          <c:cat>
            <c:strRef>
              <c:f>qGOL!$H$45:$H$46</c:f>
              <c:strCache>
                <c:ptCount val="2"/>
                <c:pt idx="0">
                  <c:v>Control</c:v>
                </c:pt>
                <c:pt idx="1">
                  <c:v>ABA</c:v>
                </c:pt>
              </c:strCache>
            </c:strRef>
          </c:cat>
          <c:val>
            <c:numRef>
              <c:f>qGOL!$I$45:$I$46</c:f>
              <c:numCache>
                <c:formatCode>General</c:formatCode>
                <c:ptCount val="2"/>
                <c:pt idx="0">
                  <c:v>2.6880324491392824E-4</c:v>
                </c:pt>
                <c:pt idx="1">
                  <c:v>1.297318469149375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28-4EE4-8B57-7ED4DBA962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1.8000000000000004E-3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CA" sz="800" b="0" i="0" baseline="0" dirty="0">
                    <a:effectLst/>
                  </a:rPr>
                  <a:t>Log2 Fold Change (Gene/</a:t>
                </a:r>
                <a:r>
                  <a:rPr lang="en-CA" sz="800" b="0" i="1" baseline="0" dirty="0">
                    <a:effectLst/>
                  </a:rPr>
                  <a:t>UBIQUITIN3</a:t>
                </a:r>
                <a:r>
                  <a:rPr lang="en-CA" sz="800" b="0" i="0" baseline="0" dirty="0">
                    <a:effectLst/>
                  </a:rPr>
                  <a:t>)</a:t>
                </a:r>
                <a:endParaRPr lang="en-CA" sz="8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123680076993617E-2"/>
              <c:y val="0.3074091300482053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  <c:majorUnit val="4.0000000000000013E-4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/>
            </a:pPr>
            <a:r>
              <a:rPr lang="en-US" sz="800" b="0" i="1"/>
              <a:t>GmADAP</a:t>
            </a:r>
          </a:p>
        </c:rich>
      </c:tx>
      <c:layout>
        <c:manualLayout>
          <c:xMode val="edge"/>
          <c:yMode val="edge"/>
          <c:x val="0.27493718161721292"/>
          <c:y val="4.848137242289531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454969860907046"/>
          <c:y val="0.1670216364823206"/>
          <c:w val="0.25366818163094368"/>
          <c:h val="0.51006601485632064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1AC-4731-ACA6-35DEE507090F}"/>
              </c:ext>
            </c:extLst>
          </c:dPt>
          <c:dLbls>
            <c:dLbl>
              <c:idx val="1"/>
              <c:tx>
                <c:rich>
                  <a:bodyPr/>
                  <a:lstStyle/>
                  <a:p>
                    <a:r>
                      <a:rPr lang="en-US" dirty="0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1AC-4731-ACA6-35DEE507090F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qADA!$J$45:$J$46</c:f>
                <c:numCache>
                  <c:formatCode>General</c:formatCode>
                  <c:ptCount val="2"/>
                  <c:pt idx="0">
                    <c:v>1.820726691100023E-5</c:v>
                  </c:pt>
                  <c:pt idx="1">
                    <c:v>9.8315915224403059E-6</c:v>
                  </c:pt>
                </c:numCache>
              </c:numRef>
            </c:plus>
            <c:minus>
              <c:numRef>
                <c:f>qADA!$J$45:$J$46</c:f>
                <c:numCache>
                  <c:formatCode>General</c:formatCode>
                  <c:ptCount val="2"/>
                  <c:pt idx="0">
                    <c:v>1.820726691100023E-5</c:v>
                  </c:pt>
                  <c:pt idx="1">
                    <c:v>9.8315915224403059E-6</c:v>
                  </c:pt>
                </c:numCache>
              </c:numRef>
            </c:minus>
            <c:spPr>
              <a:ln w="12700"/>
            </c:spPr>
          </c:errBars>
          <c:cat>
            <c:strRef>
              <c:f>'qJAZ1-6'!$H$45:$H$46</c:f>
              <c:strCache>
                <c:ptCount val="2"/>
                <c:pt idx="0">
                  <c:v>H2O</c:v>
                </c:pt>
                <c:pt idx="1">
                  <c:v>ABA</c:v>
                </c:pt>
              </c:strCache>
            </c:strRef>
          </c:cat>
          <c:val>
            <c:numRef>
              <c:f>qADA!$I$45:$I$46</c:f>
              <c:numCache>
                <c:formatCode>General</c:formatCode>
                <c:ptCount val="2"/>
                <c:pt idx="0">
                  <c:v>1.3095205872130542E-4</c:v>
                </c:pt>
                <c:pt idx="1">
                  <c:v>1.906976103761384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1AC-4731-ACA6-35DEE50709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2.5000000000000011E-4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  <c:majorUnit val="1.0000000000000003E-4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0" i="1" dirty="0">
                <a:latin typeface="Arial" panose="020B0604020202020204" pitchFamily="34" charset="0"/>
                <a:cs typeface="Arial" panose="020B0604020202020204" pitchFamily="34" charset="0"/>
              </a:rPr>
              <a:t>GmJAZ1-8/9</a:t>
            </a:r>
          </a:p>
        </c:rich>
      </c:tx>
      <c:layout>
        <c:manualLayout>
          <c:xMode val="edge"/>
          <c:yMode val="edge"/>
          <c:x val="0.13604862636851886"/>
          <c:y val="4.848140538440254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454969860907046"/>
          <c:y val="0.1670216364823206"/>
          <c:w val="0.23977882788842095"/>
          <c:h val="0.51006601485632064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552-4354-B279-F3277FC2789E}"/>
              </c:ext>
            </c:extLst>
          </c:dPt>
          <c:errBars>
            <c:errBarType val="both"/>
            <c:errValType val="cust"/>
            <c:noEndCap val="0"/>
            <c:plus>
              <c:numRef>
                <c:f>'qJAZ1-9'!$J$45:$J$46</c:f>
                <c:numCache>
                  <c:formatCode>General</c:formatCode>
                  <c:ptCount val="2"/>
                  <c:pt idx="0">
                    <c:v>9.8017076167962458E-4</c:v>
                  </c:pt>
                  <c:pt idx="1">
                    <c:v>9.2711431047833145E-4</c:v>
                  </c:pt>
                </c:numCache>
              </c:numRef>
            </c:plus>
            <c:minus>
              <c:numRef>
                <c:f>'qJAZ1-9'!$J$45:$J$46</c:f>
                <c:numCache>
                  <c:formatCode>General</c:formatCode>
                  <c:ptCount val="2"/>
                  <c:pt idx="0">
                    <c:v>9.8017076167962458E-4</c:v>
                  </c:pt>
                  <c:pt idx="1">
                    <c:v>9.2711431047833145E-4</c:v>
                  </c:pt>
                </c:numCache>
              </c:numRef>
            </c:minus>
            <c:spPr>
              <a:ln w="12700"/>
            </c:spPr>
          </c:errBars>
          <c:cat>
            <c:strRef>
              <c:f>'qJAZ1-6'!$H$45:$H$46</c:f>
              <c:strCache>
                <c:ptCount val="2"/>
                <c:pt idx="0">
                  <c:v>H2O</c:v>
                </c:pt>
                <c:pt idx="1">
                  <c:v>ABA</c:v>
                </c:pt>
              </c:strCache>
            </c:strRef>
          </c:cat>
          <c:val>
            <c:numRef>
              <c:f>'qJAZ1-9'!$I$45:$I$46</c:f>
              <c:numCache>
                <c:formatCode>General</c:formatCode>
                <c:ptCount val="2"/>
                <c:pt idx="0">
                  <c:v>9.2993281302221273E-3</c:v>
                </c:pt>
                <c:pt idx="1">
                  <c:v>1.153371124336733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52-4354-B279-F3277FC278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1.2500000000000002E-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85227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0" i="1" dirty="0">
                <a:latin typeface="Arial" panose="020B0604020202020204" pitchFamily="34" charset="0"/>
                <a:cs typeface="Arial" panose="020B0604020202020204" pitchFamily="34" charset="0"/>
              </a:rPr>
              <a:t>GmJAZ1-1</a:t>
            </a:r>
          </a:p>
        </c:rich>
      </c:tx>
      <c:layout>
        <c:manualLayout>
          <c:xMode val="edge"/>
          <c:yMode val="edge"/>
          <c:x val="0.27493718161721292"/>
          <c:y val="4.848137242289531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454969860907046"/>
          <c:y val="0.1670216364823206"/>
          <c:w val="0.25366818163094368"/>
          <c:h val="0.51006601485632064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B0C-4D16-BB3A-1DBD3BE769FA}"/>
              </c:ext>
            </c:extLst>
          </c:dPt>
          <c:errBars>
            <c:errBarType val="both"/>
            <c:errValType val="cust"/>
            <c:noEndCap val="0"/>
            <c:plus>
              <c:numRef>
                <c:f>'qJAZ1-1'!$J$45:$J$46</c:f>
                <c:numCache>
                  <c:formatCode>General</c:formatCode>
                  <c:ptCount val="2"/>
                  <c:pt idx="0">
                    <c:v>5.6838241628918155E-5</c:v>
                  </c:pt>
                  <c:pt idx="1">
                    <c:v>7.2679504022882241E-5</c:v>
                  </c:pt>
                </c:numCache>
              </c:numRef>
            </c:plus>
            <c:minus>
              <c:numRef>
                <c:f>'qJAZ1-1'!$J$45:$J$46</c:f>
                <c:numCache>
                  <c:formatCode>General</c:formatCode>
                  <c:ptCount val="2"/>
                  <c:pt idx="0">
                    <c:v>5.6838241628918155E-5</c:v>
                  </c:pt>
                  <c:pt idx="1">
                    <c:v>7.2679504022882241E-5</c:v>
                  </c:pt>
                </c:numCache>
              </c:numRef>
            </c:minus>
            <c:spPr>
              <a:ln w="12700"/>
            </c:spPr>
          </c:errBars>
          <c:cat>
            <c:strRef>
              <c:f>'qJAZ1-6'!$H$45:$H$46</c:f>
              <c:strCache>
                <c:ptCount val="2"/>
                <c:pt idx="0">
                  <c:v>H2O</c:v>
                </c:pt>
                <c:pt idx="1">
                  <c:v>ABA</c:v>
                </c:pt>
              </c:strCache>
            </c:strRef>
          </c:cat>
          <c:val>
            <c:numRef>
              <c:f>'qJAZ1-1'!$I$45:$I$46</c:f>
              <c:numCache>
                <c:formatCode>General</c:formatCode>
                <c:ptCount val="2"/>
                <c:pt idx="0">
                  <c:v>4.3533797022137925E-4</c:v>
                </c:pt>
                <c:pt idx="1">
                  <c:v>5.3295508590777958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B0C-4D16-BB3A-1DBD3BE769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6.6000000000000021E-4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8522752"/>
        <c:crosses val="autoZero"/>
        <c:crossBetween val="between"/>
        <c:majorUnit val="2.0000000000000006E-4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0" i="1" dirty="0">
                <a:latin typeface="Arial" panose="020B0604020202020204" pitchFamily="34" charset="0"/>
                <a:cs typeface="Arial" panose="020B0604020202020204" pitchFamily="34" charset="0"/>
              </a:rPr>
              <a:t>GmJAZ1-2</a:t>
            </a:r>
          </a:p>
        </c:rich>
      </c:tx>
      <c:layout>
        <c:manualLayout>
          <c:xMode val="edge"/>
          <c:yMode val="edge"/>
          <c:x val="0.27493718161721292"/>
          <c:y val="4.848137242289531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454969860907046"/>
          <c:y val="0.1670216364823206"/>
          <c:w val="0.25366818163094368"/>
          <c:h val="0.51006601485632064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CAB-4835-962D-7410F1EACEA4}"/>
              </c:ext>
            </c:extLst>
          </c:dPt>
          <c:dLbls>
            <c:dLbl>
              <c:idx val="1"/>
              <c:tx>
                <c:rich>
                  <a:bodyPr/>
                  <a:lstStyle/>
                  <a:p>
                    <a:r>
                      <a:rPr lang="en-US" dirty="0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CAB-4835-962D-7410F1EACEA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8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both"/>
            <c:errValType val="cust"/>
            <c:noEndCap val="0"/>
            <c:plus>
              <c:numRef>
                <c:f>'qJAZ1-2'!$J$45:$J$46</c:f>
                <c:numCache>
                  <c:formatCode>General</c:formatCode>
                  <c:ptCount val="2"/>
                  <c:pt idx="0">
                    <c:v>2.8130152733295351E-5</c:v>
                  </c:pt>
                  <c:pt idx="1">
                    <c:v>1.3115035444781252E-5</c:v>
                  </c:pt>
                </c:numCache>
              </c:numRef>
            </c:plus>
            <c:minus>
              <c:numRef>
                <c:f>'qJAZ1-2'!$J$45:$J$46</c:f>
                <c:numCache>
                  <c:formatCode>General</c:formatCode>
                  <c:ptCount val="2"/>
                  <c:pt idx="0">
                    <c:v>2.8130152733295351E-5</c:v>
                  </c:pt>
                  <c:pt idx="1">
                    <c:v>1.3115035444781252E-5</c:v>
                  </c:pt>
                </c:numCache>
              </c:numRef>
            </c:minus>
            <c:spPr>
              <a:ln w="12700"/>
            </c:spPr>
          </c:errBars>
          <c:cat>
            <c:strRef>
              <c:f>'qJAZ1-6'!$H$45:$H$46</c:f>
              <c:strCache>
                <c:ptCount val="2"/>
                <c:pt idx="0">
                  <c:v>H2O</c:v>
                </c:pt>
                <c:pt idx="1">
                  <c:v>ABA</c:v>
                </c:pt>
              </c:strCache>
            </c:strRef>
          </c:cat>
          <c:val>
            <c:numRef>
              <c:f>'qJAZ1-2'!$I$45:$I$46</c:f>
              <c:numCache>
                <c:formatCode>General</c:formatCode>
                <c:ptCount val="2"/>
                <c:pt idx="0">
                  <c:v>2.0828829208552601E-4</c:v>
                </c:pt>
                <c:pt idx="1">
                  <c:v>1.4002080256853759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CAB-4835-962D-7410F1EACE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2.5000000000000011E-4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8522752"/>
        <c:crosses val="autoZero"/>
        <c:crossBetween val="between"/>
        <c:majorUnit val="1.0000000000000003E-4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b="0" i="1" dirty="0">
                <a:latin typeface="Arial" panose="020B0604020202020204" pitchFamily="34" charset="0"/>
                <a:cs typeface="Arial" panose="020B0604020202020204" pitchFamily="34" charset="0"/>
              </a:rPr>
              <a:t>GmJAZ1-6</a:t>
            </a:r>
          </a:p>
        </c:rich>
      </c:tx>
      <c:layout>
        <c:manualLayout>
          <c:xMode val="edge"/>
          <c:yMode val="edge"/>
          <c:x val="0.27493718161721292"/>
          <c:y val="4.848137242289531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454969860907046"/>
          <c:y val="0.1670216364823206"/>
          <c:w val="0.25366818163094368"/>
          <c:h val="0.51006601485632064"/>
        </c:manualLayout>
      </c:layout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81EF-4DB3-90A2-A2B98154BE43}"/>
              </c:ext>
            </c:extLst>
          </c:dPt>
          <c:errBars>
            <c:errBarType val="both"/>
            <c:errValType val="cust"/>
            <c:noEndCap val="0"/>
            <c:plus>
              <c:numRef>
                <c:f>'qJAZ1-6'!$J$45:$J$46</c:f>
                <c:numCache>
                  <c:formatCode>General</c:formatCode>
                  <c:ptCount val="2"/>
                  <c:pt idx="0">
                    <c:v>8.6366500461746906E-4</c:v>
                  </c:pt>
                  <c:pt idx="1">
                    <c:v>6.6393904049408259E-4</c:v>
                  </c:pt>
                </c:numCache>
              </c:numRef>
            </c:plus>
            <c:minus>
              <c:numRef>
                <c:f>'qJAZ1-6'!$J$45:$J$46</c:f>
                <c:numCache>
                  <c:formatCode>General</c:formatCode>
                  <c:ptCount val="2"/>
                  <c:pt idx="0">
                    <c:v>8.6366500461746906E-4</c:v>
                  </c:pt>
                  <c:pt idx="1">
                    <c:v>6.6393904049408259E-4</c:v>
                  </c:pt>
                </c:numCache>
              </c:numRef>
            </c:minus>
            <c:spPr>
              <a:ln w="12700"/>
            </c:spPr>
          </c:errBars>
          <c:cat>
            <c:strRef>
              <c:f>'qJAZ1-6'!$H$45:$H$46</c:f>
              <c:strCache>
                <c:ptCount val="2"/>
                <c:pt idx="0">
                  <c:v>H2O</c:v>
                </c:pt>
                <c:pt idx="1">
                  <c:v>ABA</c:v>
                </c:pt>
              </c:strCache>
            </c:strRef>
          </c:cat>
          <c:val>
            <c:numRef>
              <c:f>'qJAZ1-6'!$I$45:$I$46</c:f>
              <c:numCache>
                <c:formatCode>General</c:formatCode>
                <c:ptCount val="2"/>
                <c:pt idx="0">
                  <c:v>9.5924467083239647E-3</c:v>
                </c:pt>
                <c:pt idx="1">
                  <c:v>1.01560376414327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EF-4DB3-90A2-A2B98154BE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  <c:max val="1.1500000000000003E-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85227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0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304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514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77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297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798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47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422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928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959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296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2879F-4B53-494B-8776-EF9F9FE2196C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2484E-3B4A-4F8B-A204-68B035601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016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061C4256-DF91-41CB-BF00-E7656E5C673C}"/>
              </a:ext>
            </a:extLst>
          </p:cNvPr>
          <p:cNvGrpSpPr/>
          <p:nvPr/>
        </p:nvGrpSpPr>
        <p:grpSpPr>
          <a:xfrm>
            <a:off x="2672080" y="2995273"/>
            <a:ext cx="2560320" cy="1995214"/>
            <a:chOff x="2600960" y="4885033"/>
            <a:chExt cx="2560320" cy="1995214"/>
          </a:xfrm>
        </p:grpSpPr>
        <p:graphicFrame>
          <p:nvGraphicFramePr>
            <p:cNvPr id="21" name="Chart 20">
              <a:extLst>
                <a:ext uri="{FF2B5EF4-FFF2-40B4-BE49-F238E27FC236}">
                  <a16:creationId xmlns:a16="http://schemas.microsoft.com/office/drawing/2014/main" id="{25A8518A-13F7-4671-A2F1-7FEA333C089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5539139"/>
                </p:ext>
              </p:extLst>
            </p:nvPr>
          </p:nvGraphicFramePr>
          <p:xfrm>
            <a:off x="2936616" y="4885033"/>
            <a:ext cx="1431807" cy="19952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1910E89-FDE8-4EF5-A34E-46123053318F}"/>
                </a:ext>
              </a:extLst>
            </p:cNvPr>
            <p:cNvSpPr/>
            <p:nvPr/>
          </p:nvSpPr>
          <p:spPr>
            <a:xfrm>
              <a:off x="2600960" y="5262880"/>
              <a:ext cx="2560320" cy="13106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24FF1F25-6CBD-4A8D-B76F-953F9B524E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5048128"/>
              </p:ext>
            </p:extLst>
          </p:nvPr>
        </p:nvGraphicFramePr>
        <p:xfrm>
          <a:off x="1503680" y="3105997"/>
          <a:ext cx="1431807" cy="1995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778AC859-A07B-49CE-9A61-54CEF01797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0875811"/>
              </p:ext>
            </p:extLst>
          </p:nvPr>
        </p:nvGraphicFramePr>
        <p:xfrm>
          <a:off x="2367915" y="3490105"/>
          <a:ext cx="727201" cy="1698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49EE6DB8-8536-4EAB-8F16-025FA4BB2B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0433884"/>
              </p:ext>
            </p:extLst>
          </p:nvPr>
        </p:nvGraphicFramePr>
        <p:xfrm>
          <a:off x="3028918" y="3486401"/>
          <a:ext cx="914401" cy="1698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FE5B6BB5-3CC3-4706-BA89-B5B9E7884E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8174859"/>
              </p:ext>
            </p:extLst>
          </p:nvPr>
        </p:nvGraphicFramePr>
        <p:xfrm>
          <a:off x="3681813" y="3486401"/>
          <a:ext cx="727201" cy="1698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39923879-F0A9-44F4-894D-37F6533C51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8115367"/>
              </p:ext>
            </p:extLst>
          </p:nvPr>
        </p:nvGraphicFramePr>
        <p:xfrm>
          <a:off x="4376992" y="3486401"/>
          <a:ext cx="727201" cy="1698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036ECF15-94C1-4287-B4AD-A943022EE88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7274347"/>
              </p:ext>
            </p:extLst>
          </p:nvPr>
        </p:nvGraphicFramePr>
        <p:xfrm>
          <a:off x="5049933" y="3483935"/>
          <a:ext cx="727201" cy="1698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4" name="Rectangle 23">
            <a:extLst>
              <a:ext uri="{FF2B5EF4-FFF2-40B4-BE49-F238E27FC236}">
                <a16:creationId xmlns:a16="http://schemas.microsoft.com/office/drawing/2014/main" id="{D0C505F9-E935-40FD-A61B-3208F35C6068}"/>
              </a:ext>
            </a:extLst>
          </p:cNvPr>
          <p:cNvSpPr/>
          <p:nvPr/>
        </p:nvSpPr>
        <p:spPr>
          <a:xfrm>
            <a:off x="1483360" y="4911358"/>
            <a:ext cx="466344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4.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levels of ABA-responsive genes in W82 seedlings treated with 100 µM ABA for 24 h measured by </a:t>
            </a:r>
            <a:r>
              <a:rPr lang="en-US" altLang="zh-CN" sz="800" kern="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CR. Treatment for 24 h did not significantly increase </a:t>
            </a:r>
            <a:r>
              <a:rPr lang="en-US" altLang="zh-CN" sz="800" i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JAZ1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 expressions as did 6 d treatment. </a:t>
            </a:r>
            <a:r>
              <a:rPr lang="en-US" altLang="zh-CN" sz="800" kern="1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ificantly different than control by paired students t-test (</a:t>
            </a:r>
            <a:r>
              <a:rPr lang="en-US" altLang="zh-CN" sz="800" i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 &lt; 0.01). Error bars represent SE (n = 4). 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2124525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93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kola Kovinich</dc:creator>
  <cp:lastModifiedBy>Nik Kovinich</cp:lastModifiedBy>
  <cp:revision>6</cp:revision>
  <dcterms:created xsi:type="dcterms:W3CDTF">2022-11-10T19:06:10Z</dcterms:created>
  <dcterms:modified xsi:type="dcterms:W3CDTF">2024-09-18T14:26:30Z</dcterms:modified>
</cp:coreProperties>
</file>